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377AC-8550-4951-A102-FBBB2769F9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785FB-A204-451A-9D6B-11B18E987C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596A2-79A9-4DEE-8E59-7CA2C08A49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DA0F6-BCF0-4695-A3DD-162245F86F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4E444-003F-4DB2-B7BE-11B79F9747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AB4E1-3A8B-465E-B7E9-4337A6970C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16B61-AFB5-465B-B590-F9B4441E67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1CE75-7ED9-49BE-A3DB-48F92EE65C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861F9B-17FF-4370-B7A3-942B4CE964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62D9C4-BCD4-4A6E-914C-6E1B2929AE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711E8-E9B0-41E3-BA92-B78913F6FA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5CD19-FEA1-4E53-840C-A4FE06835B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571040-6230-43F1-B43D-8F029099BC22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4360" y="5734080"/>
            <a:ext cx="7920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600" spc="-1" strike="noStrike">
                <a:solidFill>
                  <a:srgbClr val="000000"/>
                </a:solidFill>
                <a:latin typeface="Times New Roman"/>
              </a:rPr>
              <a:t>Figure S4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1" i="1" lang="en-GB" sz="1600" spc="-1" strike="noStrike">
                <a:solidFill>
                  <a:srgbClr val="000000"/>
                </a:solidFill>
                <a:latin typeface="Times New Roman"/>
              </a:rPr>
              <a:t>In vivo </a:t>
            </a: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aggregation of the wild-type and mutated MetAs in heat-stressed </a:t>
            </a:r>
            <a:r>
              <a:rPr b="1" lang="ko-KR" sz="1600" spc="-1" strike="noStrike">
                <a:solidFill>
                  <a:srgbClr val="000000"/>
                </a:solidFill>
                <a:latin typeface="Times New Roman"/>
              </a:rPr>
              <a:t>cells of</a:t>
            </a: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 the Δ</a:t>
            </a:r>
            <a:r>
              <a:rPr b="1" i="1" lang="en-GB" sz="1600" spc="-1" strike="noStrike">
                <a:solidFill>
                  <a:srgbClr val="000000"/>
                </a:solidFill>
                <a:latin typeface="Times New Roman"/>
              </a:rPr>
              <a:t>dnaK </a:t>
            </a: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or protease-deficient mutant strains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773360" y="1339920"/>
          <a:ext cx="5597280" cy="4179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73360" y="1339920"/>
                    <a:ext cx="5597280" cy="4179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2987640" y="1989000"/>
            <a:ext cx="1584360" cy="28440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4788000" y="1916280"/>
            <a:ext cx="1584360" cy="288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03T02:09:37Z</dcterms:created>
  <dc:creator>user</dc:creator>
  <dc:description/>
  <dc:language>en-US</dc:language>
  <cp:lastModifiedBy>user</cp:lastModifiedBy>
  <dcterms:modified xsi:type="dcterms:W3CDTF">2013-07-03T02:57:18Z</dcterms:modified>
  <cp:revision>5</cp:revision>
  <dc:subject/>
  <dc:title>슬라이드 1</dc:title>
</cp:coreProperties>
</file>